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946" r:id="rId2"/>
    <p:sldId id="943" r:id="rId3"/>
    <p:sldId id="934" r:id="rId4"/>
    <p:sldId id="944" r:id="rId5"/>
    <p:sldId id="258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792CA56-8CCE-24E2-22E3-AEED51E4393C}" name="Warren Voth" initials="WV" userId="S::u0030834@umail.utah.edu::4604e9d4-eb06-40df-90ce-5d4d9d0ce03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E9A"/>
    <a:srgbClr val="C6837B"/>
    <a:srgbClr val="CD8B7F"/>
    <a:srgbClr val="D1B4A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46"/>
    <p:restoredTop sz="97722"/>
  </p:normalViewPr>
  <p:slideViewPr>
    <p:cSldViewPr snapToGrid="0" snapToObjects="1">
      <p:cViewPr>
        <p:scale>
          <a:sx n="114" d="100"/>
          <a:sy n="114" d="100"/>
        </p:scale>
        <p:origin x="323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020905-7455-F04E-A2C9-597418051493}" type="datetimeFigureOut">
              <a:rPr lang="en-US" smtClean="0"/>
              <a:t>4/26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4F5953-9744-0B4F-9C59-4FA952E76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3235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2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+mn-ea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4F5953-9744-0B4F-9C59-4FA952E76FF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1183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2800" kern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+mn-ea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4F5953-9744-0B4F-9C59-4FA952E76FF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38209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4F5953-9744-0B4F-9C59-4FA952E76FF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89405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D75E6C-6B2D-1946-9F03-7E853E9A5E4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494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950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531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578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26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962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168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94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431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562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865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267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C40F8-5E9A-3D46-8E59-CD7AC6C07430}" type="datetimeFigureOut">
              <a:rPr lang="en-US" smtClean="0"/>
              <a:t>4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438A7-02C1-864E-8A37-DBF06C8AA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677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8.png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Relationship Id="rId9" Type="http://schemas.openxmlformats.org/officeDocument/2006/relationships/image" Target="../media/image2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04185263-BCFD-4FC3-539D-7FA211DEC92D}"/>
              </a:ext>
            </a:extLst>
          </p:cNvPr>
          <p:cNvGrpSpPr/>
          <p:nvPr/>
        </p:nvGrpSpPr>
        <p:grpSpPr>
          <a:xfrm>
            <a:off x="-53684" y="0"/>
            <a:ext cx="7079777" cy="7924333"/>
            <a:chOff x="-53684" y="0"/>
            <a:chExt cx="7079777" cy="7924333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27F50F71-3CF7-B9AA-E804-D395B6A4F32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80573" y="4763693"/>
              <a:ext cx="1822971" cy="1569331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62BC9A1B-9117-E5CA-9548-7EE4447C7FD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86069" y="4749235"/>
              <a:ext cx="1301837" cy="172336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E2D4DC2-DC02-B496-EB47-1AE22D064607}"/>
                </a:ext>
              </a:extLst>
            </p:cNvPr>
            <p:cNvSpPr txBox="1"/>
            <p:nvPr/>
          </p:nvSpPr>
          <p:spPr>
            <a:xfrm>
              <a:off x="200849" y="6724004"/>
              <a:ext cx="6657151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upplemental Figure 1. 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estern Blot of Molm-14 MPC-1 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protein in EV and MPC-1 KO cells (A). 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eahorse assay OCR 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and ECAR plots for Molm-14 (B-C) and MV4-11 (D-E) EV or MPC-1 KO cells. miR-1-3p expression with normalized counts for MV4-11 and Molm-14 EV vs MPC-1 Ko cells (F). </a:t>
              </a: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</a:rPr>
                <a:t>qPCR confirmation of MPC1 gene deletion by CRISPR/Cas9 construct in THP-1 cells (G). miR-1 expression of THP-1 MPC1 KO vs WT cells (H). 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Unpaired two-tailed t test. **** p = &lt;0.0001.</a:t>
              </a:r>
            </a:p>
            <a:p>
              <a:endParaRPr lang="en-US" sz="1200" dirty="0"/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A7BD392-CDBE-8572-32E4-FBF71781963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64229" y="2378482"/>
              <a:ext cx="2491885" cy="2119344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86D3627-7EB3-37C5-45FF-DAB84661782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43303" y="2378482"/>
              <a:ext cx="2483605" cy="2069671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5D53B23-269C-1BD7-556B-7F24186D0A8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465545" y="67473"/>
              <a:ext cx="2560548" cy="2186249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B0F0781-12A4-BC5E-5781-5995BC806FD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236339" y="67473"/>
              <a:ext cx="2552042" cy="2135209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7C8FDFC-5C85-F62F-7CFB-EC6A34F7413B}"/>
                </a:ext>
              </a:extLst>
            </p:cNvPr>
            <p:cNvSpPr txBox="1"/>
            <p:nvPr/>
          </p:nvSpPr>
          <p:spPr>
            <a:xfrm>
              <a:off x="-53684" y="0"/>
              <a:ext cx="343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.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55D0CF8-604D-B468-500E-30018C4B95B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865278" y="2339876"/>
              <a:ext cx="1738970" cy="2296114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E86C784-1148-943E-7227-3A52BFF85288}"/>
                </a:ext>
              </a:extLst>
            </p:cNvPr>
            <p:cNvSpPr txBox="1"/>
            <p:nvPr/>
          </p:nvSpPr>
          <p:spPr>
            <a:xfrm>
              <a:off x="2347075" y="0"/>
              <a:ext cx="343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.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A22AC4E-C266-7E4A-7D62-A9057F53926E}"/>
                </a:ext>
              </a:extLst>
            </p:cNvPr>
            <p:cNvSpPr txBox="1"/>
            <p:nvPr/>
          </p:nvSpPr>
          <p:spPr>
            <a:xfrm>
              <a:off x="4748549" y="0"/>
              <a:ext cx="327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.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ECC4A0D-6118-BE03-B905-DD270826E6F8}"/>
                </a:ext>
              </a:extLst>
            </p:cNvPr>
            <p:cNvSpPr txBox="1"/>
            <p:nvPr/>
          </p:nvSpPr>
          <p:spPr>
            <a:xfrm>
              <a:off x="-53684" y="2275201"/>
              <a:ext cx="343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.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315E13D-D4B7-3778-FB5D-6794A0A8E9CE}"/>
                </a:ext>
              </a:extLst>
            </p:cNvPr>
            <p:cNvSpPr txBox="1"/>
            <p:nvPr/>
          </p:nvSpPr>
          <p:spPr>
            <a:xfrm>
              <a:off x="2347075" y="2275201"/>
              <a:ext cx="3209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E.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5D5261A-0B98-E6BD-05D2-53A7DF893B50}"/>
                </a:ext>
              </a:extLst>
            </p:cNvPr>
            <p:cNvSpPr txBox="1"/>
            <p:nvPr/>
          </p:nvSpPr>
          <p:spPr>
            <a:xfrm>
              <a:off x="4748549" y="2275201"/>
              <a:ext cx="300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F.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B99ABB9-417C-E6EA-2963-30B0378F9FBE}"/>
                </a:ext>
              </a:extLst>
            </p:cNvPr>
            <p:cNvSpPr txBox="1"/>
            <p:nvPr/>
          </p:nvSpPr>
          <p:spPr>
            <a:xfrm>
              <a:off x="1599495" y="4627411"/>
              <a:ext cx="3465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G.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F2007A2-CF9A-4AE7-3A6D-113B5F59073C}"/>
                </a:ext>
              </a:extLst>
            </p:cNvPr>
            <p:cNvSpPr txBox="1"/>
            <p:nvPr/>
          </p:nvSpPr>
          <p:spPr>
            <a:xfrm>
              <a:off x="3486069" y="4619300"/>
              <a:ext cx="3465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H.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E79AFE82-E173-B6A2-5941-259A8D4AF61E}"/>
              </a:ext>
            </a:extLst>
          </p:cNvPr>
          <p:cNvGrpSpPr/>
          <p:nvPr/>
        </p:nvGrpSpPr>
        <p:grpSpPr>
          <a:xfrm>
            <a:off x="202900" y="249481"/>
            <a:ext cx="1898836" cy="1255125"/>
            <a:chOff x="2658970" y="2442683"/>
            <a:chExt cx="1898836" cy="125512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9286FD03-0816-C503-28AF-DCA26F337DE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658970" y="3064612"/>
              <a:ext cx="1234196" cy="633196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DB46B6E-1D14-F69E-B568-9492ECE0B920}"/>
                </a:ext>
              </a:extLst>
            </p:cNvPr>
            <p:cNvSpPr txBox="1"/>
            <p:nvPr/>
          </p:nvSpPr>
          <p:spPr>
            <a:xfrm>
              <a:off x="3854776" y="3032009"/>
              <a:ext cx="6190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MPC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740B262-1D35-F718-E0F4-77A1E57ED6D7}"/>
                </a:ext>
              </a:extLst>
            </p:cNvPr>
            <p:cNvSpPr txBox="1"/>
            <p:nvPr/>
          </p:nvSpPr>
          <p:spPr>
            <a:xfrm>
              <a:off x="3826516" y="3386597"/>
              <a:ext cx="7312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GAPDH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651BF74-19B2-53B8-8846-CB4CD37C9E65}"/>
                </a:ext>
              </a:extLst>
            </p:cNvPr>
            <p:cNvSpPr txBox="1"/>
            <p:nvPr/>
          </p:nvSpPr>
          <p:spPr>
            <a:xfrm>
              <a:off x="2659884" y="2802101"/>
              <a:ext cx="3754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EV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52E5B54-2CE7-DB8C-375F-BCD328D7CB3B}"/>
                </a:ext>
              </a:extLst>
            </p:cNvPr>
            <p:cNvSpPr txBox="1"/>
            <p:nvPr/>
          </p:nvSpPr>
          <p:spPr>
            <a:xfrm>
              <a:off x="3026998" y="2802101"/>
              <a:ext cx="5422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KO-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25A4250-8EAA-C9D8-8623-3E95F5C82370}"/>
                </a:ext>
              </a:extLst>
            </p:cNvPr>
            <p:cNvSpPr txBox="1"/>
            <p:nvPr/>
          </p:nvSpPr>
          <p:spPr>
            <a:xfrm>
              <a:off x="3441881" y="2802101"/>
              <a:ext cx="5422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KO-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6761601-047C-32C9-F55E-317538339934}"/>
                </a:ext>
              </a:extLst>
            </p:cNvPr>
            <p:cNvSpPr txBox="1"/>
            <p:nvPr/>
          </p:nvSpPr>
          <p:spPr>
            <a:xfrm>
              <a:off x="2913879" y="2442683"/>
              <a:ext cx="8659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u="sng" dirty="0"/>
                <a:t>Molm-1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668370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E2D4DC2-DC02-B496-EB47-1AE22D064607}"/>
              </a:ext>
            </a:extLst>
          </p:cNvPr>
          <p:cNvSpPr txBox="1"/>
          <p:nvPr/>
        </p:nvSpPr>
        <p:spPr>
          <a:xfrm>
            <a:off x="610506" y="5420350"/>
            <a:ext cx="40124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2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Patients from TCGA dataset were divided into 2 groups on the 75th percentile high and 25th percentile low (A-B) based on their mature miR-1-3p expression, and 50th percentile high and 50th percentile low (C-D).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ha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Breslow-Wilcoxon test *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p = &lt;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0.05, **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p = &lt;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0.01 was used for survival plots.</a:t>
            </a:r>
            <a:endParaRPr lang="en-US" sz="1200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AFED3EF-A89D-348D-0D78-82CF597D1ABA}"/>
              </a:ext>
            </a:extLst>
          </p:cNvPr>
          <p:cNvGrpSpPr/>
          <p:nvPr/>
        </p:nvGrpSpPr>
        <p:grpSpPr>
          <a:xfrm>
            <a:off x="393233" y="290428"/>
            <a:ext cx="4113656" cy="4988497"/>
            <a:chOff x="393233" y="290428"/>
            <a:chExt cx="4113656" cy="498849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65B4658-256A-DE43-0C73-2776FAC3E1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7094"/>
            <a:stretch/>
          </p:blipFill>
          <p:spPr>
            <a:xfrm>
              <a:off x="444033" y="834857"/>
              <a:ext cx="1224269" cy="1973844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7AD23F7-6B88-36EE-E2F9-B74A0A7E2C19}"/>
                </a:ext>
              </a:extLst>
            </p:cNvPr>
            <p:cNvSpPr txBox="1"/>
            <p:nvPr/>
          </p:nvSpPr>
          <p:spPr>
            <a:xfrm>
              <a:off x="1063472" y="504957"/>
              <a:ext cx="2637931" cy="3318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5</a:t>
              </a:r>
              <a:r>
                <a:rPr lang="en-US" sz="1200" baseline="30000" dirty="0"/>
                <a:t>th</a:t>
              </a:r>
              <a:r>
                <a:rPr lang="en-US" sz="1200" dirty="0"/>
                <a:t> Low vs 75</a:t>
              </a:r>
              <a:r>
                <a:rPr lang="en-US" sz="1200" baseline="30000" dirty="0"/>
                <a:t>th</a:t>
              </a:r>
              <a:r>
                <a:rPr lang="en-US" sz="1200" dirty="0"/>
                <a:t> High Percentile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397345A-E635-C0C8-AF32-AC5DA210DB8A}"/>
                </a:ext>
              </a:extLst>
            </p:cNvPr>
            <p:cNvSpPr txBox="1"/>
            <p:nvPr/>
          </p:nvSpPr>
          <p:spPr>
            <a:xfrm>
              <a:off x="530501" y="290428"/>
              <a:ext cx="3458744" cy="3318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urvival Based on Mature miR-1-3p Status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128E93C-678F-6A4F-7FDF-9EB1F68AA570}"/>
                </a:ext>
              </a:extLst>
            </p:cNvPr>
            <p:cNvSpPr txBox="1"/>
            <p:nvPr/>
          </p:nvSpPr>
          <p:spPr>
            <a:xfrm>
              <a:off x="973448" y="2806748"/>
              <a:ext cx="2637931" cy="3318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0</a:t>
              </a:r>
              <a:r>
                <a:rPr lang="en-US" sz="1200" baseline="30000" dirty="0"/>
                <a:t>th</a:t>
              </a:r>
              <a:r>
                <a:rPr lang="en-US" sz="1200" dirty="0"/>
                <a:t> Low vs 50</a:t>
              </a:r>
              <a:r>
                <a:rPr lang="en-US" sz="1200" baseline="30000" dirty="0"/>
                <a:t>th</a:t>
              </a:r>
              <a:r>
                <a:rPr lang="en-US" sz="1200" dirty="0"/>
                <a:t> High Percentile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632CDC4-EA1C-B2F5-D43F-DC55D4A6991A}"/>
                </a:ext>
              </a:extLst>
            </p:cNvPr>
            <p:cNvSpPr txBox="1"/>
            <p:nvPr/>
          </p:nvSpPr>
          <p:spPr>
            <a:xfrm>
              <a:off x="393233" y="859856"/>
              <a:ext cx="343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.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2A955CF-D0E6-5181-6B0D-674E32D6611E}"/>
                </a:ext>
              </a:extLst>
            </p:cNvPr>
            <p:cNvSpPr txBox="1"/>
            <p:nvPr/>
          </p:nvSpPr>
          <p:spPr>
            <a:xfrm>
              <a:off x="1899840" y="859856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.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9EB40C8-9926-8820-B292-592255681E79}"/>
                </a:ext>
              </a:extLst>
            </p:cNvPr>
            <p:cNvSpPr txBox="1"/>
            <p:nvPr/>
          </p:nvSpPr>
          <p:spPr>
            <a:xfrm>
              <a:off x="393233" y="3130996"/>
              <a:ext cx="327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.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00FDDC6-B176-11A9-B93B-99F3B4182F91}"/>
                </a:ext>
              </a:extLst>
            </p:cNvPr>
            <p:cNvSpPr txBox="1"/>
            <p:nvPr/>
          </p:nvSpPr>
          <p:spPr>
            <a:xfrm>
              <a:off x="1899840" y="3130996"/>
              <a:ext cx="3425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.</a:t>
              </a:r>
            </a:p>
          </p:txBody>
        </p:sp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EB1A55EA-68D9-9970-EF79-148953E0E59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63340" y="816381"/>
              <a:ext cx="2543549" cy="1777163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AA19E8C5-D539-E630-8FD6-19C466D6702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63340" y="3186393"/>
              <a:ext cx="2486115" cy="1777163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A30817C-62BC-80A0-B321-C065A48A1FB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44033" y="3186393"/>
              <a:ext cx="1169356" cy="20925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387695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217F08B-D9EC-6B63-25D8-F63783A724C4}"/>
              </a:ext>
            </a:extLst>
          </p:cNvPr>
          <p:cNvSpPr txBox="1"/>
          <p:nvPr/>
        </p:nvSpPr>
        <p:spPr>
          <a:xfrm>
            <a:off x="3881820" y="254624"/>
            <a:ext cx="2588845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3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iagram of miR-1 overexpression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Lenti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II EF1a GFP Hs MIR1-2 (OE) or empty vector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Lenti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III-mir-GFP Control Vector (EV) expressing lentivectors (A). Diagram of luciferase PGK1 -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plophoru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anoLuc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Luciferase Reporter (Luc) and miR-1 binding sites PGK1 -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plophoru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anoLuc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-miR1-3p Sensor Luciferase Reporter (BS) expressing vectors (B). Volcano plot of statistically significantly altered genes in miR-1 OE MV4-11 (C) and Molm-14 (D) cells compared to EV expressing MV4-11 and Molm-14 control cells respectively with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p = &lt;0.05. </a:t>
            </a:r>
            <a:endParaRPr lang="en-US" sz="1200" dirty="0"/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A641CA81-7EE5-8DEE-4D07-664852458FA5}"/>
              </a:ext>
            </a:extLst>
          </p:cNvPr>
          <p:cNvGrpSpPr/>
          <p:nvPr/>
        </p:nvGrpSpPr>
        <p:grpSpPr>
          <a:xfrm>
            <a:off x="0" y="56420"/>
            <a:ext cx="3672840" cy="8443588"/>
            <a:chOff x="0" y="56420"/>
            <a:chExt cx="3516688" cy="8084606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1102563-AB7E-28E6-96E1-A133BE9269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-2" t="8018" r="53958" b="76617"/>
            <a:stretch/>
          </p:blipFill>
          <p:spPr>
            <a:xfrm>
              <a:off x="370866" y="56420"/>
              <a:ext cx="3024185" cy="142981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D35C1D3-6D27-8364-BD2B-0C4030CEB723}"/>
                </a:ext>
              </a:extLst>
            </p:cNvPr>
            <p:cNvSpPr txBox="1"/>
            <p:nvPr/>
          </p:nvSpPr>
          <p:spPr>
            <a:xfrm>
              <a:off x="0" y="56420"/>
              <a:ext cx="3656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A.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ACD20346-9798-1A47-BD52-29CF5581C9F6}"/>
                </a:ext>
              </a:extLst>
            </p:cNvPr>
            <p:cNvGrpSpPr/>
            <p:nvPr/>
          </p:nvGrpSpPr>
          <p:grpSpPr>
            <a:xfrm>
              <a:off x="253984" y="2719665"/>
              <a:ext cx="3257949" cy="2642009"/>
              <a:chOff x="3105647" y="774130"/>
              <a:chExt cx="4242127" cy="3734820"/>
            </a:xfrm>
          </p:grpSpPr>
          <p:pic>
            <p:nvPicPr>
              <p:cNvPr id="1034" name="Picture 10">
                <a:extLst>
                  <a:ext uri="{FF2B5EF4-FFF2-40B4-BE49-F238E27FC236}">
                    <a16:creationId xmlns:a16="http://schemas.microsoft.com/office/drawing/2014/main" id="{D05C1A50-7010-91D1-F756-5F8AA1CE448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05647" y="1175851"/>
                <a:ext cx="4242127" cy="333309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FFFBF1A4-CFE2-E979-74D1-E263AB67F7AC}"/>
                  </a:ext>
                </a:extLst>
              </p:cNvPr>
              <p:cNvSpPr txBox="1"/>
              <p:nvPr/>
            </p:nvSpPr>
            <p:spPr>
              <a:xfrm>
                <a:off x="5525774" y="774130"/>
                <a:ext cx="1578480" cy="4475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miR-1 OE/EV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1AAE59DA-88BB-94E4-3254-B3F5E6B7CE75}"/>
                  </a:ext>
                </a:extLst>
              </p:cNvPr>
              <p:cNvSpPr txBox="1"/>
              <p:nvPr/>
            </p:nvSpPr>
            <p:spPr>
              <a:xfrm>
                <a:off x="3461553" y="774130"/>
                <a:ext cx="1054228" cy="4475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MV4-11</a:t>
                </a: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308928F-9B5F-D7DF-8920-F2E1E535BD1D}"/>
                </a:ext>
              </a:extLst>
            </p:cNvPr>
            <p:cNvSpPr txBox="1"/>
            <p:nvPr/>
          </p:nvSpPr>
          <p:spPr>
            <a:xfrm>
              <a:off x="0" y="2692477"/>
              <a:ext cx="3449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C.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C8CACD6B-D31D-804D-B36E-CD6192270D33}"/>
                </a:ext>
              </a:extLst>
            </p:cNvPr>
            <p:cNvGrpSpPr/>
            <p:nvPr/>
          </p:nvGrpSpPr>
          <p:grpSpPr>
            <a:xfrm>
              <a:off x="249229" y="5433076"/>
              <a:ext cx="3267459" cy="2707950"/>
              <a:chOff x="7483789" y="671635"/>
              <a:chExt cx="4254510" cy="3828039"/>
            </a:xfrm>
          </p:grpSpPr>
          <p:pic>
            <p:nvPicPr>
              <p:cNvPr id="1032" name="Picture 8">
                <a:extLst>
                  <a:ext uri="{FF2B5EF4-FFF2-40B4-BE49-F238E27FC236}">
                    <a16:creationId xmlns:a16="http://schemas.microsoft.com/office/drawing/2014/main" id="{AD44455A-E873-0EC7-FB59-67B51C77316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483789" y="1156845"/>
                <a:ext cx="4254510" cy="334282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D49559F7-EF0A-2CD0-02AF-7561413D7C2D}"/>
                  </a:ext>
                </a:extLst>
              </p:cNvPr>
              <p:cNvSpPr txBox="1"/>
              <p:nvPr/>
            </p:nvSpPr>
            <p:spPr>
              <a:xfrm>
                <a:off x="7839696" y="671635"/>
                <a:ext cx="1181265" cy="4475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Molm-14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C0211F5-C7DF-7FA9-32A7-AF720A21E586}"/>
                  </a:ext>
                </a:extLst>
              </p:cNvPr>
              <p:cNvSpPr txBox="1"/>
              <p:nvPr/>
            </p:nvSpPr>
            <p:spPr>
              <a:xfrm>
                <a:off x="9903917" y="671635"/>
                <a:ext cx="1578480" cy="4475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miR-1 OE/EV</a:t>
                </a:r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7A5CD80-78C2-3BD6-8DE0-67B2210C938C}"/>
                </a:ext>
              </a:extLst>
            </p:cNvPr>
            <p:cNvSpPr txBox="1"/>
            <p:nvPr/>
          </p:nvSpPr>
          <p:spPr>
            <a:xfrm>
              <a:off x="0" y="5430001"/>
              <a:ext cx="3645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D.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E43516B-676B-C836-A222-DDF437EFBD62}"/>
                </a:ext>
              </a:extLst>
            </p:cNvPr>
            <p:cNvSpPr txBox="1"/>
            <p:nvPr/>
          </p:nvSpPr>
          <p:spPr>
            <a:xfrm>
              <a:off x="0" y="1543338"/>
              <a:ext cx="35458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B.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06134921-EF72-72CF-9991-C4DABE99D9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8856" t="8018" r="1859" b="77231"/>
            <a:stretch/>
          </p:blipFill>
          <p:spPr>
            <a:xfrm>
              <a:off x="264412" y="1543338"/>
              <a:ext cx="3237093" cy="137271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721778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0BE3CB56-5A3F-8BB1-EFC1-BB12600C0232}"/>
              </a:ext>
            </a:extLst>
          </p:cNvPr>
          <p:cNvGrpSpPr/>
          <p:nvPr/>
        </p:nvGrpSpPr>
        <p:grpSpPr>
          <a:xfrm>
            <a:off x="1012311" y="160158"/>
            <a:ext cx="5008975" cy="7241904"/>
            <a:chOff x="867694" y="1110184"/>
            <a:chExt cx="5008975" cy="724190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89E3FA5-1233-0102-A4B8-E8590EBEA2F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62047" y="1110184"/>
              <a:ext cx="2439024" cy="219512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E363B85-42DA-5362-B1CF-2CCD11E73B1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67694" y="1110184"/>
              <a:ext cx="2439025" cy="215307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945BB86-F2CF-7E8D-F584-C782C2933122}"/>
                </a:ext>
              </a:extLst>
            </p:cNvPr>
            <p:cNvSpPr txBox="1"/>
            <p:nvPr/>
          </p:nvSpPr>
          <p:spPr>
            <a:xfrm>
              <a:off x="2776564" y="3496401"/>
              <a:ext cx="13048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V4-11cells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9DE50F3-A59A-9F69-ACDA-DE9528D6ABB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98251" y="3814396"/>
              <a:ext cx="1661985" cy="1996349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A75D432E-ABFE-38BB-ABA2-F3DF116E47E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37814" y="6332115"/>
              <a:ext cx="1750493" cy="1996349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4FC1B640-8BB2-E468-6FC5-4A780C88460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00941" y="3814396"/>
              <a:ext cx="1661985" cy="1996349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0E64E8E8-DC9A-5088-0348-87DAF276D09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25384" y="3814396"/>
              <a:ext cx="1675687" cy="2002892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59A27D29-18CD-5CEF-BB67-C4BD5FB26F6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077131" y="6326379"/>
              <a:ext cx="1799538" cy="2025709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28263FFC-749F-5888-0409-897B9372606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098251" y="6332115"/>
              <a:ext cx="1713664" cy="2012559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534F7DF-B6F1-68F3-8CD2-ED5FC11C274E}"/>
                </a:ext>
              </a:extLst>
            </p:cNvPr>
            <p:cNvSpPr txBox="1"/>
            <p:nvPr/>
          </p:nvSpPr>
          <p:spPr>
            <a:xfrm>
              <a:off x="867694" y="1110184"/>
              <a:ext cx="343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.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01DECA7-6C4A-7585-704A-FDAB6A72E454}"/>
                </a:ext>
              </a:extLst>
            </p:cNvPr>
            <p:cNvSpPr txBox="1"/>
            <p:nvPr/>
          </p:nvSpPr>
          <p:spPr>
            <a:xfrm>
              <a:off x="3257445" y="1110184"/>
              <a:ext cx="343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.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71B3518-86A2-D0BC-961D-7293DA1A94AE}"/>
                </a:ext>
              </a:extLst>
            </p:cNvPr>
            <p:cNvSpPr txBox="1"/>
            <p:nvPr/>
          </p:nvSpPr>
          <p:spPr>
            <a:xfrm>
              <a:off x="1061963" y="3814396"/>
              <a:ext cx="327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.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CCD198C-44EC-FE32-53FC-106247543D2D}"/>
                </a:ext>
              </a:extLst>
            </p:cNvPr>
            <p:cNvSpPr txBox="1"/>
            <p:nvPr/>
          </p:nvSpPr>
          <p:spPr>
            <a:xfrm>
              <a:off x="2498665" y="3814396"/>
              <a:ext cx="343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.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DCCA19E-DC3E-B178-3F2D-0E7E4D02A724}"/>
                </a:ext>
              </a:extLst>
            </p:cNvPr>
            <p:cNvSpPr txBox="1"/>
            <p:nvPr/>
          </p:nvSpPr>
          <p:spPr>
            <a:xfrm>
              <a:off x="3982891" y="3814396"/>
              <a:ext cx="3209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E.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7DE453A-F45E-4D8E-656B-C35741E7EC04}"/>
                </a:ext>
              </a:extLst>
            </p:cNvPr>
            <p:cNvSpPr txBox="1"/>
            <p:nvPr/>
          </p:nvSpPr>
          <p:spPr>
            <a:xfrm>
              <a:off x="4170356" y="6326379"/>
              <a:ext cx="3465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H.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A9418C8-1BF8-C472-42D4-D4C4056065AA}"/>
                </a:ext>
              </a:extLst>
            </p:cNvPr>
            <p:cNvSpPr txBox="1"/>
            <p:nvPr/>
          </p:nvSpPr>
          <p:spPr>
            <a:xfrm>
              <a:off x="1151786" y="6332115"/>
              <a:ext cx="300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F.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A0EE851-2CE4-9D54-DF12-40245EBDAC35}"/>
                </a:ext>
              </a:extLst>
            </p:cNvPr>
            <p:cNvSpPr txBox="1"/>
            <p:nvPr/>
          </p:nvSpPr>
          <p:spPr>
            <a:xfrm>
              <a:off x="2636012" y="6332115"/>
              <a:ext cx="3465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G.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65B97F89-DAA6-A6DE-70BF-0F695A31BB28}"/>
              </a:ext>
            </a:extLst>
          </p:cNvPr>
          <p:cNvSpPr txBox="1"/>
          <p:nvPr/>
        </p:nvSpPr>
        <p:spPr>
          <a:xfrm>
            <a:off x="1296403" y="7660863"/>
            <a:ext cx="49345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4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Seahorse assay OCR plots for MV4-11 (A) and Molm-14 (B) EV or miR-1 OE cells. Cell proliferation (C), cell death (D) and apoptosis (E) for MV4-11 EV and miR-1 OE cells. MFI of flow analysis for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Mitosox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(F),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Mitotracker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(G) and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Thioltracker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(H) assays for MV4-11 EV and miR-1 OE cells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289305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57DB20B2-F2E1-2B38-2CAA-082D450AEE06}"/>
              </a:ext>
            </a:extLst>
          </p:cNvPr>
          <p:cNvGrpSpPr/>
          <p:nvPr/>
        </p:nvGrpSpPr>
        <p:grpSpPr>
          <a:xfrm>
            <a:off x="1080324" y="516213"/>
            <a:ext cx="4575146" cy="3987605"/>
            <a:chOff x="60355" y="208264"/>
            <a:chExt cx="4575146" cy="398760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F27E0E9-FB00-3A43-4820-AACDBC7554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5357" y="265577"/>
              <a:ext cx="1809821" cy="178396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76735C9-3BA8-A7A8-51A2-4B496C6023F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56513" y="2265394"/>
              <a:ext cx="2478988" cy="190169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715D43E-A1ED-886D-CF3A-3A8A2024DC81}"/>
                </a:ext>
              </a:extLst>
            </p:cNvPr>
            <p:cNvSpPr txBox="1"/>
            <p:nvPr/>
          </p:nvSpPr>
          <p:spPr>
            <a:xfrm>
              <a:off x="60355" y="208264"/>
              <a:ext cx="343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.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25DF8707-7C52-7C45-0362-ACD738AB5525}"/>
                </a:ext>
              </a:extLst>
            </p:cNvPr>
            <p:cNvGrpSpPr/>
            <p:nvPr/>
          </p:nvGrpSpPr>
          <p:grpSpPr>
            <a:xfrm>
              <a:off x="2140148" y="208264"/>
              <a:ext cx="2010203" cy="2042493"/>
              <a:chOff x="1639836" y="263637"/>
              <a:chExt cx="1975083" cy="2006804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7E1090F-3792-356B-5B93-AE0C16347F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132590" y="339966"/>
                <a:ext cx="1482329" cy="1930475"/>
              </a:xfrm>
              <a:prstGeom prst="rect">
                <a:avLst/>
              </a:prstGeom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A240A80-F94E-DB2A-269A-38B970F64918}"/>
                  </a:ext>
                </a:extLst>
              </p:cNvPr>
              <p:cNvSpPr txBox="1"/>
              <p:nvPr/>
            </p:nvSpPr>
            <p:spPr>
              <a:xfrm>
                <a:off x="1639836" y="263637"/>
                <a:ext cx="327915" cy="3023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B.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7325B2BA-3816-A2A1-7905-0A712DA269A9}"/>
                </a:ext>
              </a:extLst>
            </p:cNvPr>
            <p:cNvGrpSpPr/>
            <p:nvPr/>
          </p:nvGrpSpPr>
          <p:grpSpPr>
            <a:xfrm>
              <a:off x="60355" y="2215864"/>
              <a:ext cx="2004659" cy="1980005"/>
              <a:chOff x="3985949" y="243384"/>
              <a:chExt cx="2004659" cy="1980005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C2DB000B-6332-F12C-1A01-D7D1BE7422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241115" y="292914"/>
                <a:ext cx="1749493" cy="1930475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BC39C2A-9BBA-55C4-358C-81724CB0528B}"/>
                  </a:ext>
                </a:extLst>
              </p:cNvPr>
              <p:cNvSpPr txBox="1"/>
              <p:nvPr/>
            </p:nvSpPr>
            <p:spPr>
              <a:xfrm>
                <a:off x="3985949" y="243384"/>
                <a:ext cx="3273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C.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EB1AA1B-C324-98C9-9039-88D5CF429876}"/>
                </a:ext>
              </a:extLst>
            </p:cNvPr>
            <p:cNvSpPr txBox="1"/>
            <p:nvPr/>
          </p:nvSpPr>
          <p:spPr>
            <a:xfrm>
              <a:off x="2140148" y="2213748"/>
              <a:ext cx="3425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.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F5F87CD2-5902-17DB-7EDB-1EC0EF0A3A93}"/>
              </a:ext>
            </a:extLst>
          </p:cNvPr>
          <p:cNvSpPr txBox="1"/>
          <p:nvPr/>
        </p:nvSpPr>
        <p:spPr>
          <a:xfrm>
            <a:off x="986976" y="4719669"/>
            <a:ext cx="466849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5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qPCR validation of mature miR-1 in C1498 miR-1 OE cells (A)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Seahorse analysis of basal respiration and maximal respiratory capacity of C1498 miR-1 OE vs C1498 EV cells (B-C). Survival of WT C57BL/6J mice that died when injected with C1498 miR-1 OE or C1498 EV cells (n=8 mice per group) (D)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93922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22</TotalTime>
  <Words>499</Words>
  <Application>Microsoft Macintosh PowerPoint</Application>
  <PresentationFormat>Letter Paper (8.5x11 in)</PresentationFormat>
  <Paragraphs>51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r-1 paper layout</dc:title>
  <dc:creator>Microsoft Office User</dc:creator>
  <cp:lastModifiedBy>Microsoft Office User</cp:lastModifiedBy>
  <cp:revision>223</cp:revision>
  <cp:lastPrinted>2022-11-03T19:59:00Z</cp:lastPrinted>
  <dcterms:created xsi:type="dcterms:W3CDTF">2021-07-27T19:21:08Z</dcterms:created>
  <dcterms:modified xsi:type="dcterms:W3CDTF">2023-04-26T17:58:32Z</dcterms:modified>
</cp:coreProperties>
</file>